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27C12-9BED-4823-8E46-19DB2BEE9A2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C86C7-65C1-4E1D-B0F3-66751F445BF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2AB831-FED9-4DCC-979D-DF2425E365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90840-E4CC-4A75-A2A6-5988F94C12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79258-E754-424D-B6F8-D0405E6F87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E3225-9072-4945-B4D2-0A44A10F7C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8B3CD9-F7E5-489D-8BE4-EA4541326B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1D7D28-6A32-4CCB-8DDC-F4D13D0AA3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2C6249-36E0-4A0D-B2EC-1B9CABBC8DB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49AC6-AC33-424B-8818-D0649815A3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EB1921-1114-4A80-B383-FE7F72D7AF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B3EB1-C76A-413E-936A-0B1CA7E319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C7BD666-56D0-41A1-9E9E-1C7BDEB466FD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feld 22"/>
          <p:cNvSpPr/>
          <p:nvPr/>
        </p:nvSpPr>
        <p:spPr>
          <a:xfrm>
            <a:off x="5580000" y="404640"/>
            <a:ext cx="2468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Healthy adults</a:t>
            </a:r>
            <a:r>
              <a:rPr b="0" lang="de-DE" sz="18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in Noun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4"/>
          <p:cNvSpPr/>
          <p:nvPr/>
        </p:nvSpPr>
        <p:spPr>
          <a:xfrm>
            <a:off x="312840" y="4508640"/>
            <a:ext cx="85168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Times New Roman"/>
              </a:rPr>
              <a:t>Supplementary material  b.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Correlation between the percentage of activated T cells and the percentage of naïve T cells in healthy adults in Nouna and Ouagadougou. In healthy controls from Ouagadougou, 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a negative correlation was observed between  activated T CD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naïve 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CD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 T cells (A). A trend toward reduced </a:t>
            </a: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naïve 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CD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 T cells  was also observed in healthy subjects from Nouna with higher percentage of activated  CD4</a:t>
            </a:r>
            <a:r>
              <a:rPr b="0" lang="de-DE" sz="14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0" lang="de-DE" sz="1400" spc="-1" strike="noStrike">
                <a:solidFill>
                  <a:srgbClr val="000000"/>
                </a:solidFill>
                <a:latin typeface="Times New Roman"/>
              </a:rPr>
              <a:t> T cells  (B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feld 25"/>
          <p:cNvSpPr/>
          <p:nvPr/>
        </p:nvSpPr>
        <p:spPr>
          <a:xfrm>
            <a:off x="971280" y="404640"/>
            <a:ext cx="316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Healthy adults in Ouagadougou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Grafik 5" descr="%CD4naive  vs CD95 ctnrl Nouna.jpg"/>
          <p:cNvPicPr/>
          <p:nvPr/>
        </p:nvPicPr>
        <p:blipFill>
          <a:blip r:embed="rId1"/>
          <a:stretch/>
        </p:blipFill>
        <p:spPr>
          <a:xfrm>
            <a:off x="4427640" y="1125360"/>
            <a:ext cx="3889440" cy="2955960"/>
          </a:xfrm>
          <a:prstGeom prst="rect">
            <a:avLst/>
          </a:prstGeom>
          <a:ln w="0">
            <a:noFill/>
          </a:ln>
        </p:spPr>
      </p:pic>
      <p:pic>
        <p:nvPicPr>
          <p:cNvPr id="45" name="Grafik 6" descr="% Naive CD4 vs CD95 control Ouaga.jpg"/>
          <p:cNvPicPr/>
          <p:nvPr/>
        </p:nvPicPr>
        <p:blipFill>
          <a:blip r:embed="rId2"/>
          <a:stretch/>
        </p:blipFill>
        <p:spPr>
          <a:xfrm>
            <a:off x="611280" y="1125360"/>
            <a:ext cx="3965400" cy="2989440"/>
          </a:xfrm>
          <a:prstGeom prst="rect">
            <a:avLst/>
          </a:prstGeom>
          <a:ln w="0">
            <a:noFill/>
          </a:ln>
        </p:spPr>
      </p:pic>
      <p:sp>
        <p:nvSpPr>
          <p:cNvPr id="46" name="Textfeld 6"/>
          <p:cNvSpPr/>
          <p:nvPr/>
        </p:nvSpPr>
        <p:spPr>
          <a:xfrm>
            <a:off x="993240" y="10018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feld 7"/>
          <p:cNvSpPr/>
          <p:nvPr/>
        </p:nvSpPr>
        <p:spPr>
          <a:xfrm>
            <a:off x="4833360" y="990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21T15:19:32Z</dcterms:created>
  <dc:creator>Fabrice Tiba</dc:creator>
  <dc:description/>
  <dc:language>en-US</dc:language>
  <cp:lastModifiedBy>LG</cp:lastModifiedBy>
  <dcterms:modified xsi:type="dcterms:W3CDTF">2011-11-04T16:39:08Z</dcterms:modified>
  <cp:revision>90</cp:revision>
  <dc:subject/>
  <dc:title>Folie 1</dc:title>
</cp:coreProperties>
</file>